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8" r:id="rId2"/>
    <p:sldId id="256" r:id="rId3"/>
    <p:sldId id="257" r:id="rId4"/>
    <p:sldId id="326" r:id="rId5"/>
    <p:sldId id="371" r:id="rId6"/>
    <p:sldId id="324" r:id="rId7"/>
    <p:sldId id="37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317"/>
    <p:restoredTop sz="96327"/>
  </p:normalViewPr>
  <p:slideViewPr>
    <p:cSldViewPr snapToGrid="0" snapToObjects="1">
      <p:cViewPr varScale="1">
        <p:scale>
          <a:sx n="92" d="100"/>
          <a:sy n="92" d="100"/>
        </p:scale>
        <p:origin x="86" y="5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shahi, Tooraj" userId="c32796c8-71d2-41ea-8983-64e73dacafcf" providerId="ADAL" clId="{E106E802-F3A9-4CF8-8148-AABC27B9B64B}"/>
    <pc:docChg chg="undo custSel modSld">
      <pc:chgData name="Mirshahi, Tooraj" userId="c32796c8-71d2-41ea-8983-64e73dacafcf" providerId="ADAL" clId="{E106E802-F3A9-4CF8-8148-AABC27B9B64B}" dt="2022-03-14T15:11:41.790" v="5" actId="20577"/>
      <pc:docMkLst>
        <pc:docMk/>
      </pc:docMkLst>
      <pc:sldChg chg="modSp mod">
        <pc:chgData name="Mirshahi, Tooraj" userId="c32796c8-71d2-41ea-8983-64e73dacafcf" providerId="ADAL" clId="{E106E802-F3A9-4CF8-8148-AABC27B9B64B}" dt="2022-03-14T15:08:22.425" v="3" actId="1076"/>
        <pc:sldMkLst>
          <pc:docMk/>
          <pc:sldMk cId="36023785" sldId="258"/>
        </pc:sldMkLst>
        <pc:spChg chg="mod">
          <ac:chgData name="Mirshahi, Tooraj" userId="c32796c8-71d2-41ea-8983-64e73dacafcf" providerId="ADAL" clId="{E106E802-F3A9-4CF8-8148-AABC27B9B64B}" dt="2022-03-14T15:08:22.425" v="3" actId="1076"/>
          <ac:spMkLst>
            <pc:docMk/>
            <pc:sldMk cId="36023785" sldId="258"/>
            <ac:spMk id="16" creationId="{AF0C7B6F-0955-48ED-9674-02E0B50EE5F7}"/>
          </ac:spMkLst>
        </pc:spChg>
      </pc:sldChg>
      <pc:sldChg chg="modSp mod">
        <pc:chgData name="Mirshahi, Tooraj" userId="c32796c8-71d2-41ea-8983-64e73dacafcf" providerId="ADAL" clId="{E106E802-F3A9-4CF8-8148-AABC27B9B64B}" dt="2022-03-14T15:11:38.539" v="4" actId="20577"/>
        <pc:sldMkLst>
          <pc:docMk/>
          <pc:sldMk cId="3190121474" sldId="326"/>
        </pc:sldMkLst>
        <pc:spChg chg="mod">
          <ac:chgData name="Mirshahi, Tooraj" userId="c32796c8-71d2-41ea-8983-64e73dacafcf" providerId="ADAL" clId="{E106E802-F3A9-4CF8-8148-AABC27B9B64B}" dt="2022-03-14T15:11:38.539" v="4" actId="20577"/>
          <ac:spMkLst>
            <pc:docMk/>
            <pc:sldMk cId="3190121474" sldId="326"/>
            <ac:spMk id="52" creationId="{5221CE88-C107-465F-B08E-96B235A2A3F8}"/>
          </ac:spMkLst>
        </pc:spChg>
      </pc:sldChg>
      <pc:sldChg chg="modSp mod">
        <pc:chgData name="Mirshahi, Tooraj" userId="c32796c8-71d2-41ea-8983-64e73dacafcf" providerId="ADAL" clId="{E106E802-F3A9-4CF8-8148-AABC27B9B64B}" dt="2022-03-14T15:11:41.790" v="5" actId="20577"/>
        <pc:sldMkLst>
          <pc:docMk/>
          <pc:sldMk cId="2013946485" sldId="371"/>
        </pc:sldMkLst>
        <pc:spChg chg="mod">
          <ac:chgData name="Mirshahi, Tooraj" userId="c32796c8-71d2-41ea-8983-64e73dacafcf" providerId="ADAL" clId="{E106E802-F3A9-4CF8-8148-AABC27B9B64B}" dt="2022-03-14T15:11:41.790" v="5" actId="20577"/>
          <ac:spMkLst>
            <pc:docMk/>
            <pc:sldMk cId="2013946485" sldId="371"/>
            <ac:spMk id="4" creationId="{AFD03439-E40A-46BC-946E-9D7B7F3D599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7F3E3A-FEBA-9943-9610-4A81EA9113BD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D8844D-8814-214C-AF3A-6B0578B84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638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4FEA59-AB27-374D-8114-106C3E7A65D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9269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8277C3-F802-FC47-8617-FA3127A29B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3697D1-E339-3C4F-AEDE-B3EF308537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383563-8239-9B40-B672-9E0C89D6F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08575B-A133-9642-A64E-061B40A98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4C4AAA-4812-EC4D-8430-4D41E38F6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865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EBB85-524E-7946-B4D4-75DA12292A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537892-4022-FA4B-A0D8-34D7C8BF4D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1813E2-62BE-824D-8A6F-A3F306FB0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628575-2A77-8343-9012-AE3DCB03D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4FC952-5578-5948-A71B-5D40F2A28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688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80BBCA-A720-0F46-9E06-2EC7CF1991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FD786B-18D9-A344-8C85-7483776EF1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E83FC-AE00-7B4C-B788-6C22C72CD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33512A-DB38-0348-8A99-882270E0C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52CA79-0DE9-2E48-9D48-FD9B8CC8E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367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E36F7F-13F4-FE4F-B941-21F1A9293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9A4AE4-DE13-5340-8E1C-6587B68215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5636A2-067F-674A-A71A-5551B6A2EF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28D0F4-B3E6-4646-A83A-F38EF3B8B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E15818-FD19-2E43-9EF7-10CFAF2503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15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1C69F-82FE-D14F-9162-9E55D1983B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634905-09D3-524F-BBBE-C5835458A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A997EF-03FB-B947-B692-58D8D2E52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D2B754-FFE7-D84B-A7C5-15D60A700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E51F3F-7C03-364B-AB27-3E0944BD5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01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46D8BC-EE59-AE44-B306-5977175C61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BF70E4-3B74-AE4F-AD32-83FFAB91C0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CBC1CF-56C7-3C4A-AA85-EB11F6B6C5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E8C33F-EC90-E64D-9D2B-20D281D78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42DD2E-718B-864D-ABEA-638020983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0E03AE-5B74-BD43-AB2E-314545C8B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857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44954E-7587-444D-8645-42992CABD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232741-041E-2C45-85F8-7BB58B343A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FF9D52-D646-6E4C-A734-EC52F13B0A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13BD321-3AE2-3E43-82EE-9E926EB911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4969F4-E326-864A-8FA6-4EA19471DA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E442E2-B500-4E4D-A0A3-71652C5C7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A64E69-6446-7F4E-B941-FF0E6B769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29DF9F8-D4C6-E64B-8A73-67A83D2DD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128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3706F-0F54-C34F-8A12-75C2C4736F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0597B9-ACD3-954D-8F7C-8CD3CA514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DD7436-073B-7544-896C-381F4CC71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F40FFF-AC39-3F48-8E53-810DA674DE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801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F1A64E-ED25-4546-8AF4-CCB899728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118A39A-E3CA-224B-ADCB-69AF4D020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434E69-C0B2-8848-9E97-45763293A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958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F3D58D-78BF-9646-B5F9-A2DF33D6C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7EF849-AA5E-9444-9220-D14E743EA3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6222C8-4E6B-1D41-A654-363645DBE3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370E64-C122-6A40-8E3B-FCE4C3523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893E00-5F2E-4841-BA0D-750A19CBB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9B9AC9-81FC-534D-8BFD-B7ED18774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32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05CAF1-D204-A244-8949-D7BEEEAA1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7ADADF-CC24-8144-A5EC-E359C5F2D7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0E05FB-E4A7-2049-89C8-B21C237822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85667F-2850-D14E-8F56-31C4B1203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5A2773-2A1C-784E-9D36-54E4B29E0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54B3FF-13CC-9A49-B764-8E241DC0D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748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D364F2-9969-D44E-9A0F-D186FFFE98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4AB2E8-E2F3-0E47-A6E1-EF870E255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B0D63F-29C4-A448-895D-14E8A3345F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7C855-B92B-7C49-B7DD-A9676664A9AA}" type="datetimeFigureOut">
              <a:rPr lang="en-US" smtClean="0"/>
              <a:t>3/1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C6260-1075-8442-9422-EC2BA259DC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4A6295-88C2-AB42-B837-B75F4C7E54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154F46-0940-124A-A09A-19C7F048E5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311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tiff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"/><Relationship Id="rId13" Type="http://schemas.openxmlformats.org/officeDocument/2006/relationships/image" Target="../media/image20.png"/><Relationship Id="rId18" Type="http://schemas.openxmlformats.org/officeDocument/2006/relationships/image" Target="../media/image25.png"/><Relationship Id="rId3" Type="http://schemas.openxmlformats.org/officeDocument/2006/relationships/image" Target="../media/image12.png"/><Relationship Id="rId7" Type="http://schemas.openxmlformats.org/officeDocument/2006/relationships/image" Target="../media/image1.tif"/><Relationship Id="rId12" Type="http://schemas.openxmlformats.org/officeDocument/2006/relationships/image" Target="../media/image19.svg"/><Relationship Id="rId17" Type="http://schemas.openxmlformats.org/officeDocument/2006/relationships/image" Target="../media/image24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svg"/><Relationship Id="rId11" Type="http://schemas.openxmlformats.org/officeDocument/2006/relationships/image" Target="../media/image18.png"/><Relationship Id="rId5" Type="http://schemas.openxmlformats.org/officeDocument/2006/relationships/image" Target="../media/image14.png"/><Relationship Id="rId15" Type="http://schemas.openxmlformats.org/officeDocument/2006/relationships/image" Target="../media/image22.png"/><Relationship Id="rId10" Type="http://schemas.openxmlformats.org/officeDocument/2006/relationships/image" Target="../media/image17.svg"/><Relationship Id="rId19" Type="http://schemas.openxmlformats.org/officeDocument/2006/relationships/image" Target="../media/image26.png"/><Relationship Id="rId4" Type="http://schemas.openxmlformats.org/officeDocument/2006/relationships/image" Target="../media/image13.svg"/><Relationship Id="rId9" Type="http://schemas.openxmlformats.org/officeDocument/2006/relationships/image" Target="../media/image16.png"/><Relationship Id="rId14" Type="http://schemas.openxmlformats.org/officeDocument/2006/relationships/image" Target="../media/image21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"/><Relationship Id="rId2" Type="http://schemas.openxmlformats.org/officeDocument/2006/relationships/image" Target="../media/image27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9B9A7D-8FBA-40CD-948A-F07A0285A662}"/>
              </a:ext>
            </a:extLst>
          </p:cNvPr>
          <p:cNvSpPr txBox="1"/>
          <p:nvPr/>
        </p:nvSpPr>
        <p:spPr>
          <a:xfrm>
            <a:off x="1456514" y="570935"/>
            <a:ext cx="940727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ample Abdominal CTs/MRI for Typical ADPKD: </a:t>
            </a:r>
            <a:r>
              <a:rPr lang="en-US" sz="1600" i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ilateral and diffuse distribution of cysts, with moderate or severe replacement of kidney tissue by cysts, where all cysts contribute similarly to total kidney volume</a:t>
            </a:r>
            <a:endParaRPr lang="en-US" i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 descr="A close-up of the moon&#10;&#10;Description automatically generated with medium confidence">
            <a:extLst>
              <a:ext uri="{FF2B5EF4-FFF2-40B4-BE49-F238E27FC236}">
                <a16:creationId xmlns:a16="http://schemas.microsoft.com/office/drawing/2014/main" id="{BC8EEAD0-5304-4143-A333-EF536AF506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5" t="7813" r="1042" b="-223"/>
          <a:stretch/>
        </p:blipFill>
        <p:spPr>
          <a:xfrm>
            <a:off x="1420212" y="2251720"/>
            <a:ext cx="2926080" cy="21945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60CF8AB-1C3B-4982-8C03-0E6FCC5CEB02}"/>
              </a:ext>
            </a:extLst>
          </p:cNvPr>
          <p:cNvSpPr txBox="1"/>
          <p:nvPr/>
        </p:nvSpPr>
        <p:spPr>
          <a:xfrm>
            <a:off x="2024261" y="1555002"/>
            <a:ext cx="171798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5-60 year-old female:</a:t>
            </a:r>
          </a:p>
          <a:p>
            <a:pPr algn="ctr"/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1_Gly2034Val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960D2A52-F8A8-46F1-94F7-FB4D7D3A32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6" t="2083" r="1826" b="2083"/>
          <a:stretch/>
        </p:blipFill>
        <p:spPr>
          <a:xfrm>
            <a:off x="7880668" y="2251720"/>
            <a:ext cx="2926080" cy="219456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A35FB38-40E9-41F2-B790-D416B4E70E4C}"/>
              </a:ext>
            </a:extLst>
          </p:cNvPr>
          <p:cNvSpPr txBox="1"/>
          <p:nvPr/>
        </p:nvSpPr>
        <p:spPr>
          <a:xfrm>
            <a:off x="8548866" y="1576267"/>
            <a:ext cx="1807245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5-60 year-old male:</a:t>
            </a:r>
          </a:p>
          <a:p>
            <a:pPr algn="ctr"/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FT140_Arg1404Gln</a:t>
            </a:r>
          </a:p>
          <a:p>
            <a:pPr algn="ctr"/>
            <a:r>
              <a:rPr lang="en-US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RI)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14" name="Picture 13" descr="A picture containing text, person&#10;&#10;Description automatically generated">
            <a:extLst>
              <a:ext uri="{FF2B5EF4-FFF2-40B4-BE49-F238E27FC236}">
                <a16:creationId xmlns:a16="http://schemas.microsoft.com/office/drawing/2014/main" id="{497C504A-D578-45CD-87D5-A789DDE6552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3" t="12963" r="1083" b="-1851"/>
          <a:stretch/>
        </p:blipFill>
        <p:spPr>
          <a:xfrm>
            <a:off x="4632960" y="2251720"/>
            <a:ext cx="2926080" cy="219456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AF0C7B6F-0955-48ED-9674-02E0B50EE5F7}"/>
              </a:ext>
            </a:extLst>
          </p:cNvPr>
          <p:cNvSpPr txBox="1"/>
          <p:nvPr/>
        </p:nvSpPr>
        <p:spPr>
          <a:xfrm>
            <a:off x="5241933" y="1662724"/>
            <a:ext cx="180724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5-30 year-old male:</a:t>
            </a:r>
          </a:p>
          <a:p>
            <a:pPr algn="ctr"/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1_Arg3719Gln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237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D11D4158-9C0A-4C89-A0B6-95EFA518CEB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062" b="10937"/>
          <a:stretch/>
        </p:blipFill>
        <p:spPr>
          <a:xfrm>
            <a:off x="2841695" y="4177122"/>
            <a:ext cx="2926080" cy="21945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B352B2-DAD0-4D2B-99BA-41390E889865}"/>
              </a:ext>
            </a:extLst>
          </p:cNvPr>
          <p:cNvSpPr txBox="1"/>
          <p:nvPr/>
        </p:nvSpPr>
        <p:spPr>
          <a:xfrm>
            <a:off x="2587153" y="204284"/>
            <a:ext cx="722898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xample Abdominal CTs for Mild ADPKD: </a:t>
            </a:r>
            <a:r>
              <a:rPr lang="en-US" sz="1600" i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ilateral/diffuse replacement of kidney tissue by cysts</a:t>
            </a:r>
            <a:endParaRPr lang="en-US" i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1AC59A-DC1D-4648-87C2-D90221853F85}"/>
              </a:ext>
            </a:extLst>
          </p:cNvPr>
          <p:cNvSpPr txBox="1"/>
          <p:nvPr/>
        </p:nvSpPr>
        <p:spPr>
          <a:xfrm>
            <a:off x="3376351" y="842025"/>
            <a:ext cx="19832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5-50 year-old female:</a:t>
            </a:r>
          </a:p>
          <a:p>
            <a:pPr algn="ctr"/>
            <a:r>
              <a:rPr lang="en-US" sz="1400" b="0" i="1" dirty="0">
                <a:solidFill>
                  <a:srgbClr val="24242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1_Asp1165Gly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61616AB-3685-4ABA-9897-7F3696BA336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56" t="1" r="5556" b="3193"/>
          <a:stretch/>
        </p:blipFill>
        <p:spPr>
          <a:xfrm>
            <a:off x="2841695" y="1340770"/>
            <a:ext cx="2926080" cy="219456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4CE4B12-D27C-4FF3-B10B-DB9D80CC7A30}"/>
              </a:ext>
            </a:extLst>
          </p:cNvPr>
          <p:cNvSpPr txBox="1"/>
          <p:nvPr/>
        </p:nvSpPr>
        <p:spPr>
          <a:xfrm>
            <a:off x="3274880" y="3699131"/>
            <a:ext cx="21861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5-30 year-old female:</a:t>
            </a:r>
          </a:p>
          <a:p>
            <a:pPr algn="ctr"/>
            <a:r>
              <a:rPr lang="en-US" sz="1400" b="0" i="1" dirty="0">
                <a:solidFill>
                  <a:srgbClr val="24242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2_Arg786GlyfsTer25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picture containing group&#10;&#10;Description automatically generated">
            <a:extLst>
              <a:ext uri="{FF2B5EF4-FFF2-40B4-BE49-F238E27FC236}">
                <a16:creationId xmlns:a16="http://schemas.microsoft.com/office/drawing/2014/main" id="{E536DBB3-E136-4581-B5E0-640C1827809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4" r="653" b="12727"/>
          <a:stretch/>
        </p:blipFill>
        <p:spPr>
          <a:xfrm>
            <a:off x="6009526" y="1340770"/>
            <a:ext cx="2926080" cy="219456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B37F797-355D-43F0-90D9-4912CB8A3B3E}"/>
              </a:ext>
            </a:extLst>
          </p:cNvPr>
          <p:cNvSpPr txBox="1"/>
          <p:nvPr/>
        </p:nvSpPr>
        <p:spPr>
          <a:xfrm>
            <a:off x="5657932" y="818942"/>
            <a:ext cx="350538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5-40 year-old male:</a:t>
            </a:r>
          </a:p>
          <a:p>
            <a:pPr algn="ctr"/>
            <a:r>
              <a:rPr lang="en-US" sz="1400" b="0" i="1" dirty="0">
                <a:solidFill>
                  <a:srgbClr val="24242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2_ Gln300Ter </a:t>
            </a:r>
            <a:r>
              <a:rPr lang="en-US" sz="1400" b="0" i="0" dirty="0">
                <a:solidFill>
                  <a:srgbClr val="24242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400" b="0" i="1" dirty="0">
                <a:solidFill>
                  <a:srgbClr val="24242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2 _hr1237Met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 descr="A black and white photo of a handbag&#10;&#10;Description automatically generated with low confidence">
            <a:extLst>
              <a:ext uri="{FF2B5EF4-FFF2-40B4-BE49-F238E27FC236}">
                <a16:creationId xmlns:a16="http://schemas.microsoft.com/office/drawing/2014/main" id="{C970F99A-E8E8-4AD3-AD0F-C40C9A26EAE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90" t="26585" r="33590" b="26585"/>
          <a:stretch/>
        </p:blipFill>
        <p:spPr>
          <a:xfrm>
            <a:off x="6009526" y="4177122"/>
            <a:ext cx="2926080" cy="219456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E9FAA5C7-8756-4B64-A4B7-B1420ED9AD91}"/>
              </a:ext>
            </a:extLst>
          </p:cNvPr>
          <p:cNvSpPr txBox="1"/>
          <p:nvPr/>
        </p:nvSpPr>
        <p:spPr>
          <a:xfrm>
            <a:off x="6464807" y="3699131"/>
            <a:ext cx="18341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-55 year-old male:</a:t>
            </a:r>
          </a:p>
          <a:p>
            <a:pPr algn="ctr"/>
            <a:r>
              <a:rPr lang="en-US" sz="1400" b="0" i="1" dirty="0">
                <a:solidFill>
                  <a:srgbClr val="242424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NAB_Asp647Val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6594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9B352B2-DAD0-4D2B-99BA-41390E889865}"/>
              </a:ext>
            </a:extLst>
          </p:cNvPr>
          <p:cNvSpPr txBox="1"/>
          <p:nvPr/>
        </p:nvSpPr>
        <p:spPr>
          <a:xfrm>
            <a:off x="1176268" y="154531"/>
            <a:ext cx="8855114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xample Abdominal CTs for Atypical ADPKD: </a:t>
            </a:r>
            <a:r>
              <a:rPr lang="en-US" sz="1600" i="1" u="sng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er Mayo clinic imaging classification (see </a:t>
            </a:r>
            <a:r>
              <a:rPr lang="en-US" sz="1600" i="1" u="sng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razabal</a:t>
            </a:r>
            <a:r>
              <a:rPr lang="en-US" sz="1600" i="1" u="sng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V, et al. J Am Soc Nephrol. 2015;26(1):160-72.)</a:t>
            </a:r>
            <a:r>
              <a:rPr lang="en-US" sz="16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close-up of an x-ray&#10;&#10;Description automatically generated with low confidence">
            <a:extLst>
              <a:ext uri="{FF2B5EF4-FFF2-40B4-BE49-F238E27FC236}">
                <a16:creationId xmlns:a16="http://schemas.microsoft.com/office/drawing/2014/main" id="{E962F2B6-4B4B-43F4-A719-4D500AA8291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0" t="1172" r="5449" b="1172"/>
          <a:stretch/>
        </p:blipFill>
        <p:spPr>
          <a:xfrm>
            <a:off x="1597029" y="1275601"/>
            <a:ext cx="3017520" cy="219456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7FCFFB7-A1D2-48DB-83E7-D25EF981C9F0}"/>
              </a:ext>
            </a:extLst>
          </p:cNvPr>
          <p:cNvSpPr txBox="1"/>
          <p:nvPr/>
        </p:nvSpPr>
        <p:spPr>
          <a:xfrm>
            <a:off x="1855817" y="785473"/>
            <a:ext cx="249994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-45 year-old male:</a:t>
            </a:r>
          </a:p>
          <a:p>
            <a:pPr algn="ctr"/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1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_</a:t>
            </a:r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y2034Val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11" name="Picture 10" descr="A picture containing text&#10;&#10;Description automatically generated">
            <a:extLst>
              <a:ext uri="{FF2B5EF4-FFF2-40B4-BE49-F238E27FC236}">
                <a16:creationId xmlns:a16="http://schemas.microsoft.com/office/drawing/2014/main" id="{53C5360F-0405-4A4A-8540-D67278F3B96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5" t="2083" r="4215" b="2083"/>
          <a:stretch/>
        </p:blipFill>
        <p:spPr>
          <a:xfrm>
            <a:off x="6236901" y="1275601"/>
            <a:ext cx="3108960" cy="219456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8B7B39BD-6B87-40EC-8710-6B2A0DDE5C08}"/>
              </a:ext>
            </a:extLst>
          </p:cNvPr>
          <p:cNvSpPr txBox="1"/>
          <p:nvPr/>
        </p:nvSpPr>
        <p:spPr>
          <a:xfrm>
            <a:off x="6282621" y="785473"/>
            <a:ext cx="301752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5-80 year-old male:</a:t>
            </a:r>
          </a:p>
          <a:p>
            <a:pPr algn="ctr"/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FT140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p653Ter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3FD101A1-EEA9-4109-B5B3-2A5B468186B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1743" b="15665"/>
          <a:stretch/>
        </p:blipFill>
        <p:spPr>
          <a:xfrm>
            <a:off x="1642749" y="4130409"/>
            <a:ext cx="2926080" cy="219456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0CE6434D-25C9-4213-8BE3-796D58F10101}"/>
              </a:ext>
            </a:extLst>
          </p:cNvPr>
          <p:cNvSpPr txBox="1"/>
          <p:nvPr/>
        </p:nvSpPr>
        <p:spPr>
          <a:xfrm>
            <a:off x="1973086" y="3608035"/>
            <a:ext cx="226540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0-75 year-old male:</a:t>
            </a:r>
          </a:p>
          <a:p>
            <a:pPr algn="ctr"/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KD1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la3889Ser</a:t>
            </a:r>
            <a:endParaRPr lang="en-US" sz="1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 descr="A picture containing text&#10;&#10;Description automatically generated">
            <a:extLst>
              <a:ext uri="{FF2B5EF4-FFF2-40B4-BE49-F238E27FC236}">
                <a16:creationId xmlns:a16="http://schemas.microsoft.com/office/drawing/2014/main" id="{6DEBCBC9-FE0D-425B-9D31-0D49D39F332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7" t="15301" r="25387" b="15301"/>
          <a:stretch/>
        </p:blipFill>
        <p:spPr>
          <a:xfrm>
            <a:off x="6328341" y="4130409"/>
            <a:ext cx="2926080" cy="219456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F377AB5D-0C79-4934-8A1A-058458656288}"/>
              </a:ext>
            </a:extLst>
          </p:cNvPr>
          <p:cNvSpPr txBox="1"/>
          <p:nvPr/>
        </p:nvSpPr>
        <p:spPr>
          <a:xfrm>
            <a:off x="6282621" y="3608035"/>
            <a:ext cx="301752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0-35 year-old female:</a:t>
            </a:r>
          </a:p>
          <a:p>
            <a:pPr algn="ctr"/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NAB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sp647Val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0834018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>
            <a:extLst>
              <a:ext uri="{FF2B5EF4-FFF2-40B4-BE49-F238E27FC236}">
                <a16:creationId xmlns:a16="http://schemas.microsoft.com/office/drawing/2014/main" id="{5221CE88-C107-465F-B08E-96B235A2A3F8}"/>
              </a:ext>
            </a:extLst>
          </p:cNvPr>
          <p:cNvSpPr txBox="1"/>
          <p:nvPr/>
        </p:nvSpPr>
        <p:spPr>
          <a:xfrm>
            <a:off x="1396348" y="355121"/>
            <a:ext cx="94240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Variants in patients with other kidney diseases:  ADPKD family history only, ARPKD, or TSC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EDCEF8A-0C01-487C-A531-7B85EBAB71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5812023"/>
              </p:ext>
            </p:extLst>
          </p:nvPr>
        </p:nvGraphicFramePr>
        <p:xfrm>
          <a:off x="944511" y="1004327"/>
          <a:ext cx="10107082" cy="416017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52692">
                  <a:extLst>
                    <a:ext uri="{9D8B030D-6E8A-4147-A177-3AD203B41FA5}">
                      <a16:colId xmlns:a16="http://schemas.microsoft.com/office/drawing/2014/main" val="2832525760"/>
                    </a:ext>
                  </a:extLst>
                </a:gridCol>
                <a:gridCol w="394854">
                  <a:extLst>
                    <a:ext uri="{9D8B030D-6E8A-4147-A177-3AD203B41FA5}">
                      <a16:colId xmlns:a16="http://schemas.microsoft.com/office/drawing/2014/main" val="2623926330"/>
                    </a:ext>
                  </a:extLst>
                </a:gridCol>
                <a:gridCol w="509155">
                  <a:extLst>
                    <a:ext uri="{9D8B030D-6E8A-4147-A177-3AD203B41FA5}">
                      <a16:colId xmlns:a16="http://schemas.microsoft.com/office/drawing/2014/main" val="1281492303"/>
                    </a:ext>
                  </a:extLst>
                </a:gridCol>
                <a:gridCol w="1589809">
                  <a:extLst>
                    <a:ext uri="{9D8B030D-6E8A-4147-A177-3AD203B41FA5}">
                      <a16:colId xmlns:a16="http://schemas.microsoft.com/office/drawing/2014/main" val="3237483033"/>
                    </a:ext>
                  </a:extLst>
                </a:gridCol>
                <a:gridCol w="2039890">
                  <a:extLst>
                    <a:ext uri="{9D8B030D-6E8A-4147-A177-3AD203B41FA5}">
                      <a16:colId xmlns:a16="http://schemas.microsoft.com/office/drawing/2014/main" val="2769248088"/>
                    </a:ext>
                  </a:extLst>
                </a:gridCol>
                <a:gridCol w="609792">
                  <a:extLst>
                    <a:ext uri="{9D8B030D-6E8A-4147-A177-3AD203B41FA5}">
                      <a16:colId xmlns:a16="http://schemas.microsoft.com/office/drawing/2014/main" val="3846213016"/>
                    </a:ext>
                  </a:extLst>
                </a:gridCol>
                <a:gridCol w="841663">
                  <a:extLst>
                    <a:ext uri="{9D8B030D-6E8A-4147-A177-3AD203B41FA5}">
                      <a16:colId xmlns:a16="http://schemas.microsoft.com/office/drawing/2014/main" val="1738410423"/>
                    </a:ext>
                  </a:extLst>
                </a:gridCol>
                <a:gridCol w="737755">
                  <a:extLst>
                    <a:ext uri="{9D8B030D-6E8A-4147-A177-3AD203B41FA5}">
                      <a16:colId xmlns:a16="http://schemas.microsoft.com/office/drawing/2014/main" val="1457549267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988918764"/>
                    </a:ext>
                  </a:extLst>
                </a:gridCol>
                <a:gridCol w="1745672">
                  <a:extLst>
                    <a:ext uri="{9D8B030D-6E8A-4147-A177-3AD203B41FA5}">
                      <a16:colId xmlns:a16="http://schemas.microsoft.com/office/drawing/2014/main" val="1245700231"/>
                    </a:ext>
                  </a:extLst>
                </a:gridCol>
              </a:tblGrid>
              <a:tr h="2430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_I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enotyp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:Pos:Ref:Al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VSp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S MAF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nomAD MAF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B Call (PKD1/PKD2) </a:t>
                      </a:r>
                    </a:p>
                    <a:p>
                      <a:pPr algn="l" fontAlgn="ctr"/>
                      <a:r>
                        <a:rPr lang="en-US" sz="10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Var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ll ( PKHD1/TSC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9592632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26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-4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PKD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:52058349:G:A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HD1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496Ter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46318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6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-5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PKD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97945312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7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-3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PKD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:52024750:A: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HD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e1687Thr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ic/Likely 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5085649"/>
                  </a:ext>
                </a:extLst>
              </a:tr>
              <a:tr h="2430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1466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-4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PKD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:6:51619080:51619520  6:51659907:G:A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HD1  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V_del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Gln3407Ter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4135679"/>
                  </a:ext>
                </a:extLst>
              </a:tr>
              <a:tr h="2430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33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-4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PKD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:6:51619080:51619520  6:51659907:G:A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HD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V_del      Gln3407Ter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3485489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5281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-2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KU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:4:86354529:8635452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V_del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0053475"/>
                  </a:ext>
                </a:extLst>
              </a:tr>
              <a:tr h="36302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27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-3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KU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:78318845:G:A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:78477959:A:G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6:51141732:T: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AS1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AS1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L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a666Thr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e2666Val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164Gly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4e-06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0000547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000051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3e-06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0001424</a:t>
                      </a:r>
                    </a:p>
                    <a:p>
                      <a:pPr algn="l" fontAlgn="ctr"/>
                      <a:r>
                        <a:rPr lang="en-US" sz="10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8602574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5364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-2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KU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:52076302:T: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HD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n141Ar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8901937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27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-6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C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:2056705:C:T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C2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237Leu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flictin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6798664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7164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-1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:2080179:C: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C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1138Ter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0125365"/>
                  </a:ext>
                </a:extLst>
              </a:tr>
              <a:tr h="24300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32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-4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 hx of ADPKD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:88038501:CGTAA:C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2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e donor variant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in PKDB     Pathogenic/Likely 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0552416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3908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-2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 hx of ADPKD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:2092573:A:G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1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p3726Arg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 Likely 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3395414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4722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-1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 hx of ADPKD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:2091121:C:T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1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p3922Ter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initely 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9107686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5732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-3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 hx of ADPKD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:2092573:A: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1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p3726Arg</a:t>
                      </a:r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 Likely 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6428015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34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-4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 hx of ADPKD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4717690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PKD17101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-45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ple liver &amp; renal cysts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:88043387:C: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D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417Ter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initely Pathogenic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R="2978" marT="297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94015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901214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4DFCE47-32FE-48FB-A6F1-6986F5A520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8414439"/>
              </p:ext>
            </p:extLst>
          </p:nvPr>
        </p:nvGraphicFramePr>
        <p:xfrm>
          <a:off x="2112069" y="1148938"/>
          <a:ext cx="8143759" cy="4804014"/>
        </p:xfrm>
        <a:graphic>
          <a:graphicData uri="http://schemas.openxmlformats.org/drawingml/2006/table">
            <a:tbl>
              <a:tblPr>
                <a:tableStyleId>{00A15C55-8517-42AA-B614-E9B94910E393}</a:tableStyleId>
              </a:tblPr>
              <a:tblGrid>
                <a:gridCol w="1046768">
                  <a:extLst>
                    <a:ext uri="{9D8B030D-6E8A-4147-A177-3AD203B41FA5}">
                      <a16:colId xmlns:a16="http://schemas.microsoft.com/office/drawing/2014/main" val="1802985896"/>
                    </a:ext>
                  </a:extLst>
                </a:gridCol>
                <a:gridCol w="519545">
                  <a:extLst>
                    <a:ext uri="{9D8B030D-6E8A-4147-A177-3AD203B41FA5}">
                      <a16:colId xmlns:a16="http://schemas.microsoft.com/office/drawing/2014/main" val="4282155752"/>
                    </a:ext>
                  </a:extLst>
                </a:gridCol>
                <a:gridCol w="1672937">
                  <a:extLst>
                    <a:ext uri="{9D8B030D-6E8A-4147-A177-3AD203B41FA5}">
                      <a16:colId xmlns:a16="http://schemas.microsoft.com/office/drawing/2014/main" val="4288247476"/>
                    </a:ext>
                  </a:extLst>
                </a:gridCol>
                <a:gridCol w="2441863">
                  <a:extLst>
                    <a:ext uri="{9D8B030D-6E8A-4147-A177-3AD203B41FA5}">
                      <a16:colId xmlns:a16="http://schemas.microsoft.com/office/drawing/2014/main" val="1046147288"/>
                    </a:ext>
                  </a:extLst>
                </a:gridCol>
                <a:gridCol w="893618">
                  <a:extLst>
                    <a:ext uri="{9D8B030D-6E8A-4147-A177-3AD203B41FA5}">
                      <a16:colId xmlns:a16="http://schemas.microsoft.com/office/drawing/2014/main" val="2522373950"/>
                    </a:ext>
                  </a:extLst>
                </a:gridCol>
                <a:gridCol w="696191">
                  <a:extLst>
                    <a:ext uri="{9D8B030D-6E8A-4147-A177-3AD203B41FA5}">
                      <a16:colId xmlns:a16="http://schemas.microsoft.com/office/drawing/2014/main" val="763985219"/>
                    </a:ext>
                  </a:extLst>
                </a:gridCol>
                <a:gridCol w="872837">
                  <a:extLst>
                    <a:ext uri="{9D8B030D-6E8A-4147-A177-3AD203B41FA5}">
                      <a16:colId xmlns:a16="http://schemas.microsoft.com/office/drawing/2014/main" val="1092999448"/>
                    </a:ext>
                  </a:extLst>
                </a:gridCol>
              </a:tblGrid>
              <a:tr h="2320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_I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GVSp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r:Pos:Ref:Al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B call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# carriers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ith ADPK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51442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50710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ys51Tyr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35538: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, 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674738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276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u727del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14840:TGCA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7766108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258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u727del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14840:TGCA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830052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07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u727del Val1971Me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14840:TGCA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84432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30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1164Ar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11677: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243539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346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l1544del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10534:TCA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010111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7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2034Val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9066:C:A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681314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99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2098_ Gly2102del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8860:GCCCTGGCGACCCATC: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748828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33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a2511Pro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6263:C: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kely benign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73766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33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a2552Pro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6140:C: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090890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79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n2784Pro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3706:T: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242628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6885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ly2785Ar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3704:C: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780072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33568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g3039His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2466: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635089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15075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3173Leu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0446:G:A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992598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5161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ys3232Glu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100184:T:C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US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128942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207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3304Asn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9874: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49715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336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3304Asn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9874: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518369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285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3304Asn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9874: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393046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sp3304Asn Gly3361Ar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9874:C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253519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18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3591Phe  Gly3361Ar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3860:G:A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154001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198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3591Phe Gly3361Ar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3860:G:A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687097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4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3591Phe Gly3361Ar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3860:G:A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450952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70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a3915Pro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:2091144:C:G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606124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95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g320Leu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:88038366:G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90831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DPKD261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KD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g320Leu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:88038366:G:T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 reported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R="5715" marT="571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789325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AFD03439-E40A-46BC-946E-9D7B7F3D599E}"/>
              </a:ext>
            </a:extLst>
          </p:cNvPr>
          <p:cNvSpPr txBox="1"/>
          <p:nvPr/>
        </p:nvSpPr>
        <p:spPr>
          <a:xfrm>
            <a:off x="2065995" y="487963"/>
            <a:ext cx="806000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Table 2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arriers of variants in 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KD1/PKD2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at are novel, indeterminate, or likely benign in the PKDB.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39464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58">
            <a:extLst>
              <a:ext uri="{FF2B5EF4-FFF2-40B4-BE49-F238E27FC236}">
                <a16:creationId xmlns:a16="http://schemas.microsoft.com/office/drawing/2014/main" id="{AF187133-CBF6-4C2C-902C-22C327A4C3CB}"/>
              </a:ext>
            </a:extLst>
          </p:cNvPr>
          <p:cNvSpPr txBox="1"/>
          <p:nvPr/>
        </p:nvSpPr>
        <p:spPr>
          <a:xfrm>
            <a:off x="1023444" y="60130"/>
            <a:ext cx="1014511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edigrees and imaging of carriers of novel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KD1 Gly2034Va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ssense variant.  Three out of four carriers have ADPKD, while the one without current evidence of ADPKD is &lt;25 years old (*). Non-carrier relatives in either family do not have an ADPKD phenotyp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digree and available CT imaging for carrier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KD1 Asp3304As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total, 6/10 have imaging evidence of ADPKD, 3 are shown.  Of the 4 carriers with no evidence, 3 do not have abdominal imaging and one is under age 40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edigree and imaging for carrier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KD1Ser3591Phe, of whom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 of 3 have ADPKD. While non-carrier family members do not have ADPKD.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61C746E-B1C6-45D1-B70E-6E4C61231B2C}"/>
              </a:ext>
            </a:extLst>
          </p:cNvPr>
          <p:cNvSpPr txBox="1"/>
          <p:nvPr/>
        </p:nvSpPr>
        <p:spPr>
          <a:xfrm>
            <a:off x="1898561" y="1061191"/>
            <a:ext cx="189987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sz="1350" i="1" dirty="0">
                <a:latin typeface="Arial" panose="020B0604020202020204" pitchFamily="34" charset="0"/>
                <a:cs typeface="Arial" panose="020B0604020202020204" pitchFamily="34" charset="0"/>
              </a:rPr>
              <a:t> PKD1_Gly2034Val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Graphic 15">
            <a:extLst>
              <a:ext uri="{FF2B5EF4-FFF2-40B4-BE49-F238E27FC236}">
                <a16:creationId xmlns:a16="http://schemas.microsoft.com/office/drawing/2014/main" id="{696EC2F7-09DC-4F08-9E02-EB12B4C7425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l="35222" t="20001" r="29483" b="32729"/>
          <a:stretch/>
        </p:blipFill>
        <p:spPr>
          <a:xfrm>
            <a:off x="2279661" y="1446942"/>
            <a:ext cx="1028700" cy="1783080"/>
          </a:xfrm>
          <a:prstGeom prst="rect">
            <a:avLst/>
          </a:prstGeom>
        </p:spPr>
      </p:pic>
      <p:pic>
        <p:nvPicPr>
          <p:cNvPr id="24" name="Graphic 23">
            <a:extLst>
              <a:ext uri="{FF2B5EF4-FFF2-40B4-BE49-F238E27FC236}">
                <a16:creationId xmlns:a16="http://schemas.microsoft.com/office/drawing/2014/main" id="{1CB11B4A-C130-4D76-991B-616F4D831C2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rcRect l="27342" t="25885" r="43566" b="14653"/>
          <a:stretch/>
        </p:blipFill>
        <p:spPr>
          <a:xfrm>
            <a:off x="6694207" y="1204842"/>
            <a:ext cx="1099989" cy="1737360"/>
          </a:xfrm>
          <a:prstGeom prst="rect">
            <a:avLst/>
          </a:prstGeom>
        </p:spPr>
      </p:pic>
      <p:pic>
        <p:nvPicPr>
          <p:cNvPr id="9" name="Picture 8" descr="A close-up of the moon&#10;&#10;Description automatically generated with medium confidence">
            <a:extLst>
              <a:ext uri="{FF2B5EF4-FFF2-40B4-BE49-F238E27FC236}">
                <a16:creationId xmlns:a16="http://schemas.microsoft.com/office/drawing/2014/main" id="{902FB492-FFC0-0A49-82D0-4C2023D43EE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14" t="6477" r="3291" b="-47"/>
          <a:stretch/>
        </p:blipFill>
        <p:spPr>
          <a:xfrm>
            <a:off x="4450356" y="1516842"/>
            <a:ext cx="1508760" cy="1207008"/>
          </a:xfrm>
          <a:prstGeom prst="rect">
            <a:avLst/>
          </a:prstGeom>
        </p:spPr>
      </p:pic>
      <p:pic>
        <p:nvPicPr>
          <p:cNvPr id="25" name="Picture 24" descr="A close-up of a skull&#10;&#10;Description automatically generated with low confidence">
            <a:extLst>
              <a:ext uri="{FF2B5EF4-FFF2-40B4-BE49-F238E27FC236}">
                <a16:creationId xmlns:a16="http://schemas.microsoft.com/office/drawing/2014/main" id="{DB2D0F87-D371-9F41-A95F-AE7DB766BDB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26" t="597" r="5337" b="867"/>
          <a:stretch/>
        </p:blipFill>
        <p:spPr>
          <a:xfrm>
            <a:off x="8289125" y="1579843"/>
            <a:ext cx="1508760" cy="1097280"/>
          </a:xfrm>
          <a:prstGeom prst="rect">
            <a:avLst/>
          </a:prstGeom>
        </p:spPr>
      </p:pic>
      <p:pic>
        <p:nvPicPr>
          <p:cNvPr id="28" name="Graphic 27">
            <a:extLst>
              <a:ext uri="{FF2B5EF4-FFF2-40B4-BE49-F238E27FC236}">
                <a16:creationId xmlns:a16="http://schemas.microsoft.com/office/drawing/2014/main" id="{E0C53971-6197-7447-918D-BBF8320B457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rcRect l="35222" t="20002" r="41248" b="50909"/>
          <a:stretch/>
        </p:blipFill>
        <p:spPr>
          <a:xfrm>
            <a:off x="7038763" y="3736386"/>
            <a:ext cx="685800" cy="1097280"/>
          </a:xfrm>
          <a:prstGeom prst="rect">
            <a:avLst/>
          </a:prstGeom>
        </p:spPr>
      </p:pic>
      <p:pic>
        <p:nvPicPr>
          <p:cNvPr id="29" name="Graphic 28">
            <a:extLst>
              <a:ext uri="{FF2B5EF4-FFF2-40B4-BE49-F238E27FC236}">
                <a16:creationId xmlns:a16="http://schemas.microsoft.com/office/drawing/2014/main" id="{DC2DC7AE-1056-C141-8492-C24FAD627AC4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rcRect l="32868" t="16364" r="41249" b="65455"/>
          <a:stretch/>
        </p:blipFill>
        <p:spPr>
          <a:xfrm>
            <a:off x="2937590" y="3690875"/>
            <a:ext cx="754380" cy="685800"/>
          </a:xfrm>
          <a:prstGeom prst="rect">
            <a:avLst/>
          </a:prstGeom>
        </p:spPr>
      </p:pic>
      <p:pic>
        <p:nvPicPr>
          <p:cNvPr id="30" name="Graphic 29">
            <a:extLst>
              <a:ext uri="{FF2B5EF4-FFF2-40B4-BE49-F238E27FC236}">
                <a16:creationId xmlns:a16="http://schemas.microsoft.com/office/drawing/2014/main" id="{DE0E986C-8F57-1945-8445-7B18F58CBEA7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rcRect l="35222" t="20002" r="41248" b="52727"/>
          <a:stretch/>
        </p:blipFill>
        <p:spPr>
          <a:xfrm>
            <a:off x="3715823" y="5262963"/>
            <a:ext cx="685800" cy="1028700"/>
          </a:xfrm>
          <a:prstGeom prst="rect">
            <a:avLst/>
          </a:prstGeom>
        </p:spPr>
      </p:pic>
      <p:pic>
        <p:nvPicPr>
          <p:cNvPr id="32" name="Picture 31" descr="A close-up of a brain&#10;&#10;Description automatically generated with low confidence">
            <a:extLst>
              <a:ext uri="{FF2B5EF4-FFF2-40B4-BE49-F238E27FC236}">
                <a16:creationId xmlns:a16="http://schemas.microsoft.com/office/drawing/2014/main" id="{8BC0E644-E03E-ED42-A9D0-09C7DC7623A9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462"/>
          <a:stretch/>
        </p:blipFill>
        <p:spPr>
          <a:xfrm>
            <a:off x="7718577" y="5454853"/>
            <a:ext cx="1264621" cy="984077"/>
          </a:xfrm>
          <a:prstGeom prst="rect">
            <a:avLst/>
          </a:prstGeom>
        </p:spPr>
      </p:pic>
      <p:pic>
        <p:nvPicPr>
          <p:cNvPr id="35" name="Picture 34" descr="A picture containing text&#10;&#10;Description automatically generated">
            <a:extLst>
              <a:ext uri="{FF2B5EF4-FFF2-40B4-BE49-F238E27FC236}">
                <a16:creationId xmlns:a16="http://schemas.microsoft.com/office/drawing/2014/main" id="{2074007D-CE78-A24D-AC5C-3D5BCBFD0108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42" b="28556"/>
          <a:stretch/>
        </p:blipFill>
        <p:spPr>
          <a:xfrm>
            <a:off x="5389993" y="3627515"/>
            <a:ext cx="1325351" cy="1028824"/>
          </a:xfrm>
          <a:prstGeom prst="rect">
            <a:avLst/>
          </a:prstGeom>
        </p:spPr>
      </p:pic>
      <p:pic>
        <p:nvPicPr>
          <p:cNvPr id="38" name="Picture 37" descr="A close-up of a brain&#10;&#10;Description automatically generated with low confidence">
            <a:extLst>
              <a:ext uri="{FF2B5EF4-FFF2-40B4-BE49-F238E27FC236}">
                <a16:creationId xmlns:a16="http://schemas.microsoft.com/office/drawing/2014/main" id="{69EA436D-70FB-9642-BA68-086AA6B00598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9" t="5748" r="6259" b="36172"/>
          <a:stretch/>
        </p:blipFill>
        <p:spPr>
          <a:xfrm>
            <a:off x="3941389" y="3631575"/>
            <a:ext cx="1324305" cy="1028824"/>
          </a:xfrm>
          <a:prstGeom prst="rect">
            <a:avLst/>
          </a:prstGeom>
        </p:spPr>
      </p:pic>
      <p:pic>
        <p:nvPicPr>
          <p:cNvPr id="41" name="Picture 40" descr="A picture containing text&#10;&#10;Description automatically generated">
            <a:extLst>
              <a:ext uri="{FF2B5EF4-FFF2-40B4-BE49-F238E27FC236}">
                <a16:creationId xmlns:a16="http://schemas.microsoft.com/office/drawing/2014/main" id="{2B5D845A-5E82-0B4E-AACF-B284EE1B4568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4" t="4375" r="7800" b="29873"/>
          <a:stretch/>
        </p:blipFill>
        <p:spPr>
          <a:xfrm>
            <a:off x="8586975" y="3738852"/>
            <a:ext cx="1379066" cy="1028825"/>
          </a:xfrm>
          <a:prstGeom prst="rect">
            <a:avLst/>
          </a:prstGeom>
        </p:spPr>
      </p:pic>
      <p:pic>
        <p:nvPicPr>
          <p:cNvPr id="44" name="Picture 43" descr="A picture containing text, several&#10;&#10;Description automatically generated">
            <a:extLst>
              <a:ext uri="{FF2B5EF4-FFF2-40B4-BE49-F238E27FC236}">
                <a16:creationId xmlns:a16="http://schemas.microsoft.com/office/drawing/2014/main" id="{1B3C04BC-4913-C54E-A07F-E9A56752EE88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586"/>
          <a:stretch/>
        </p:blipFill>
        <p:spPr>
          <a:xfrm>
            <a:off x="5994438" y="5476197"/>
            <a:ext cx="1296771" cy="975617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3A4B4F2E-ADF5-0647-9785-1A70030B67D4}"/>
              </a:ext>
            </a:extLst>
          </p:cNvPr>
          <p:cNvSpPr txBox="1"/>
          <p:nvPr/>
        </p:nvSpPr>
        <p:spPr>
          <a:xfrm>
            <a:off x="1898561" y="3284733"/>
            <a:ext cx="218317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350" i="1" dirty="0">
                <a:latin typeface="Arial" panose="020B0604020202020204" pitchFamily="34" charset="0"/>
                <a:cs typeface="Arial" panose="020B0604020202020204" pitchFamily="34" charset="0"/>
              </a:rPr>
              <a:t> PKD1_Asp3304Asn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A032CF1-791B-EB40-95BB-D92BA02C871E}"/>
              </a:ext>
            </a:extLst>
          </p:cNvPr>
          <p:cNvSpPr txBox="1"/>
          <p:nvPr/>
        </p:nvSpPr>
        <p:spPr>
          <a:xfrm>
            <a:off x="1898561" y="4911247"/>
            <a:ext cx="205887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350" i="1" dirty="0">
                <a:latin typeface="Arial" panose="020B0604020202020204" pitchFamily="34" charset="0"/>
                <a:cs typeface="Arial" panose="020B0604020202020204" pitchFamily="34" charset="0"/>
              </a:rPr>
              <a:t>PKD1_Ser3591Phe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E49D7C98-7164-9A4D-BA2B-616AE0A43981}"/>
              </a:ext>
            </a:extLst>
          </p:cNvPr>
          <p:cNvSpPr/>
          <p:nvPr/>
        </p:nvSpPr>
        <p:spPr>
          <a:xfrm>
            <a:off x="2604470" y="2099751"/>
            <a:ext cx="392051" cy="622092"/>
          </a:xfrm>
          <a:prstGeom prst="rect">
            <a:avLst/>
          </a:prstGeom>
          <a:solidFill>
            <a:schemeClr val="accent2">
              <a:lumMod val="40000"/>
              <a:lumOff val="60000"/>
              <a:alpha val="3268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F88C35C-FDC4-F942-AFF6-C7815F957170}"/>
              </a:ext>
            </a:extLst>
          </p:cNvPr>
          <p:cNvSpPr txBox="1"/>
          <p:nvPr/>
        </p:nvSpPr>
        <p:spPr>
          <a:xfrm>
            <a:off x="2627197" y="2506399"/>
            <a:ext cx="38503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 image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t 55-60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E808F839-3D62-054E-A89E-A214524D006E}"/>
              </a:ext>
            </a:extLst>
          </p:cNvPr>
          <p:cNvCxnSpPr>
            <a:cxnSpLocks/>
            <a:stCxn id="47" idx="3"/>
          </p:cNvCxnSpPr>
          <p:nvPr/>
        </p:nvCxnSpPr>
        <p:spPr>
          <a:xfrm>
            <a:off x="2996521" y="2410797"/>
            <a:ext cx="1453835" cy="9631"/>
          </a:xfrm>
          <a:prstGeom prst="straightConnector1">
            <a:avLst/>
          </a:prstGeom>
          <a:ln w="19050">
            <a:solidFill>
              <a:schemeClr val="accent2">
                <a:lumMod val="40000"/>
                <a:lumOff val="6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27A0FBCB-A143-3E40-B2B6-121CB3360C67}"/>
              </a:ext>
            </a:extLst>
          </p:cNvPr>
          <p:cNvSpPr/>
          <p:nvPr/>
        </p:nvSpPr>
        <p:spPr>
          <a:xfrm>
            <a:off x="6830839" y="2534441"/>
            <a:ext cx="392051" cy="622092"/>
          </a:xfrm>
          <a:prstGeom prst="rect">
            <a:avLst/>
          </a:prstGeom>
          <a:solidFill>
            <a:schemeClr val="accent2">
              <a:lumMod val="40000"/>
              <a:lumOff val="60000"/>
              <a:alpha val="3268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F25B959-5427-F642-BEB3-B7BBC8F18527}"/>
              </a:ext>
            </a:extLst>
          </p:cNvPr>
          <p:cNvSpPr txBox="1"/>
          <p:nvPr/>
        </p:nvSpPr>
        <p:spPr>
          <a:xfrm>
            <a:off x="6853566" y="2941089"/>
            <a:ext cx="38503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 image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t 40-45</a:t>
            </a:r>
          </a:p>
        </p:txBody>
      </p:sp>
      <p:cxnSp>
        <p:nvCxnSpPr>
          <p:cNvPr id="8" name="Elbow Connector 7">
            <a:extLst>
              <a:ext uri="{FF2B5EF4-FFF2-40B4-BE49-F238E27FC236}">
                <a16:creationId xmlns:a16="http://schemas.microsoft.com/office/drawing/2014/main" id="{72FD9274-DAEB-5B4D-9D54-568ACC2E43A3}"/>
              </a:ext>
            </a:extLst>
          </p:cNvPr>
          <p:cNvCxnSpPr>
            <a:cxnSpLocks/>
            <a:stCxn id="51" idx="3"/>
            <a:endCxn id="25" idx="1"/>
          </p:cNvCxnSpPr>
          <p:nvPr/>
        </p:nvCxnSpPr>
        <p:spPr>
          <a:xfrm flipV="1">
            <a:off x="7222890" y="2128483"/>
            <a:ext cx="1066235" cy="717004"/>
          </a:xfrm>
          <a:prstGeom prst="bentConnector3">
            <a:avLst>
              <a:gd name="adj1" fmla="val 50000"/>
            </a:avLst>
          </a:prstGeom>
          <a:ln w="19050">
            <a:solidFill>
              <a:schemeClr val="accent2">
                <a:lumMod val="40000"/>
                <a:lumOff val="6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>
            <a:extLst>
              <a:ext uri="{FF2B5EF4-FFF2-40B4-BE49-F238E27FC236}">
                <a16:creationId xmlns:a16="http://schemas.microsoft.com/office/drawing/2014/main" id="{4F4B6500-6CEF-CA4E-9FC9-F7B7F7CC5599}"/>
              </a:ext>
            </a:extLst>
          </p:cNvPr>
          <p:cNvSpPr/>
          <p:nvPr/>
        </p:nvSpPr>
        <p:spPr>
          <a:xfrm>
            <a:off x="2891639" y="3828281"/>
            <a:ext cx="392051" cy="812889"/>
          </a:xfrm>
          <a:prstGeom prst="rect">
            <a:avLst/>
          </a:prstGeom>
          <a:solidFill>
            <a:schemeClr val="accent2">
              <a:lumMod val="40000"/>
              <a:lumOff val="60000"/>
              <a:alpha val="3268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0B63739-16F4-6D40-918E-564577F18AF8}"/>
              </a:ext>
            </a:extLst>
          </p:cNvPr>
          <p:cNvSpPr txBox="1"/>
          <p:nvPr/>
        </p:nvSpPr>
        <p:spPr>
          <a:xfrm>
            <a:off x="2922050" y="4293478"/>
            <a:ext cx="38503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 image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t 60-65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4E82FDA6-3D6B-C344-8D49-DE7BAA9DA203}"/>
              </a:ext>
            </a:extLst>
          </p:cNvPr>
          <p:cNvSpPr/>
          <p:nvPr/>
        </p:nvSpPr>
        <p:spPr>
          <a:xfrm>
            <a:off x="3313859" y="3830782"/>
            <a:ext cx="392051" cy="812890"/>
          </a:xfrm>
          <a:prstGeom prst="rect">
            <a:avLst/>
          </a:prstGeom>
          <a:solidFill>
            <a:schemeClr val="accent2">
              <a:lumMod val="40000"/>
              <a:lumOff val="60000"/>
              <a:alpha val="3268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D23325B-2F4D-6141-97EC-A79B990483BD}"/>
              </a:ext>
            </a:extLst>
          </p:cNvPr>
          <p:cNvSpPr txBox="1"/>
          <p:nvPr/>
        </p:nvSpPr>
        <p:spPr>
          <a:xfrm>
            <a:off x="3314101" y="4409815"/>
            <a:ext cx="38503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 image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t 60-65</a:t>
            </a:r>
          </a:p>
        </p:txBody>
      </p:sp>
      <p:cxnSp>
        <p:nvCxnSpPr>
          <p:cNvPr id="17" name="Elbow Connector 16">
            <a:extLst>
              <a:ext uri="{FF2B5EF4-FFF2-40B4-BE49-F238E27FC236}">
                <a16:creationId xmlns:a16="http://schemas.microsoft.com/office/drawing/2014/main" id="{F7AE26BC-3728-D343-8DA7-40C0C60AE43B}"/>
              </a:ext>
            </a:extLst>
          </p:cNvPr>
          <p:cNvCxnSpPr>
            <a:cxnSpLocks/>
            <a:stCxn id="54" idx="2"/>
            <a:endCxn id="38" idx="2"/>
          </p:cNvCxnSpPr>
          <p:nvPr/>
        </p:nvCxnSpPr>
        <p:spPr>
          <a:xfrm rot="16200000" flipH="1">
            <a:off x="3835989" y="3892845"/>
            <a:ext cx="19229" cy="1515877"/>
          </a:xfrm>
          <a:prstGeom prst="bentConnector3">
            <a:avLst>
              <a:gd name="adj1" fmla="val 1288829"/>
            </a:avLst>
          </a:prstGeom>
          <a:ln w="19050">
            <a:solidFill>
              <a:schemeClr val="accent2">
                <a:lumMod val="40000"/>
                <a:lumOff val="6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Elbow Connector 61">
            <a:extLst>
              <a:ext uri="{FF2B5EF4-FFF2-40B4-BE49-F238E27FC236}">
                <a16:creationId xmlns:a16="http://schemas.microsoft.com/office/drawing/2014/main" id="{E602B5AB-8BBD-F645-BADA-FFF8FCBF5D88}"/>
              </a:ext>
            </a:extLst>
          </p:cNvPr>
          <p:cNvCxnSpPr>
            <a:stCxn id="58" idx="2"/>
            <a:endCxn id="35" idx="2"/>
          </p:cNvCxnSpPr>
          <p:nvPr/>
        </p:nvCxnSpPr>
        <p:spPr>
          <a:xfrm rot="16200000" flipH="1">
            <a:off x="4764104" y="3367774"/>
            <a:ext cx="31080" cy="2546049"/>
          </a:xfrm>
          <a:prstGeom prst="bentConnector3">
            <a:avLst>
              <a:gd name="adj1" fmla="val 835521"/>
            </a:avLst>
          </a:prstGeom>
          <a:ln w="19050">
            <a:solidFill>
              <a:schemeClr val="accent2">
                <a:lumMod val="40000"/>
                <a:lumOff val="6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>
            <a:extLst>
              <a:ext uri="{FF2B5EF4-FFF2-40B4-BE49-F238E27FC236}">
                <a16:creationId xmlns:a16="http://schemas.microsoft.com/office/drawing/2014/main" id="{48C38D7F-E44B-3049-A857-819B5D60712C}"/>
              </a:ext>
            </a:extLst>
          </p:cNvPr>
          <p:cNvSpPr/>
          <p:nvPr/>
        </p:nvSpPr>
        <p:spPr>
          <a:xfrm>
            <a:off x="6939044" y="3736388"/>
            <a:ext cx="392051" cy="685798"/>
          </a:xfrm>
          <a:prstGeom prst="rect">
            <a:avLst/>
          </a:prstGeom>
          <a:solidFill>
            <a:schemeClr val="accent2">
              <a:lumMod val="40000"/>
              <a:lumOff val="60000"/>
              <a:alpha val="3268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FED7B04-C6B2-1342-9542-DDDA485015F0}"/>
              </a:ext>
            </a:extLst>
          </p:cNvPr>
          <p:cNvSpPr txBox="1"/>
          <p:nvPr/>
        </p:nvSpPr>
        <p:spPr>
          <a:xfrm>
            <a:off x="6946058" y="4141532"/>
            <a:ext cx="38503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 image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t 70-75</a:t>
            </a:r>
          </a:p>
        </p:txBody>
      </p:sp>
      <p:cxnSp>
        <p:nvCxnSpPr>
          <p:cNvPr id="66" name="Elbow Connector 65">
            <a:extLst>
              <a:ext uri="{FF2B5EF4-FFF2-40B4-BE49-F238E27FC236}">
                <a16:creationId xmlns:a16="http://schemas.microsoft.com/office/drawing/2014/main" id="{242DEFE8-CB6F-3543-8103-80DD6195E816}"/>
              </a:ext>
            </a:extLst>
          </p:cNvPr>
          <p:cNvCxnSpPr>
            <a:cxnSpLocks/>
            <a:stCxn id="64" idx="3"/>
            <a:endCxn id="41" idx="1"/>
          </p:cNvCxnSpPr>
          <p:nvPr/>
        </p:nvCxnSpPr>
        <p:spPr>
          <a:xfrm>
            <a:off x="7331095" y="4079287"/>
            <a:ext cx="1255880" cy="173978"/>
          </a:xfrm>
          <a:prstGeom prst="bentConnector3">
            <a:avLst>
              <a:gd name="adj1" fmla="val 13912"/>
            </a:avLst>
          </a:prstGeom>
          <a:ln w="19050">
            <a:solidFill>
              <a:schemeClr val="accent2">
                <a:lumMod val="40000"/>
                <a:lumOff val="6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>
            <a:extLst>
              <a:ext uri="{FF2B5EF4-FFF2-40B4-BE49-F238E27FC236}">
                <a16:creationId xmlns:a16="http://schemas.microsoft.com/office/drawing/2014/main" id="{DB454E70-D6F8-6C4C-9E9C-87785FD10ED7}"/>
              </a:ext>
            </a:extLst>
          </p:cNvPr>
          <p:cNvSpPr/>
          <p:nvPr/>
        </p:nvSpPr>
        <p:spPr>
          <a:xfrm>
            <a:off x="3669992" y="5262963"/>
            <a:ext cx="392051" cy="638278"/>
          </a:xfrm>
          <a:prstGeom prst="rect">
            <a:avLst/>
          </a:prstGeom>
          <a:solidFill>
            <a:schemeClr val="accent2">
              <a:lumMod val="40000"/>
              <a:lumOff val="60000"/>
              <a:alpha val="3268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E459BD8-8F58-DF44-B650-A200A3AD5621}"/>
              </a:ext>
            </a:extLst>
          </p:cNvPr>
          <p:cNvSpPr txBox="1"/>
          <p:nvPr/>
        </p:nvSpPr>
        <p:spPr>
          <a:xfrm>
            <a:off x="3670234" y="5667384"/>
            <a:ext cx="38503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 image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t 40-45</a:t>
            </a:r>
          </a:p>
        </p:txBody>
      </p:sp>
      <p:cxnSp>
        <p:nvCxnSpPr>
          <p:cNvPr id="73" name="Elbow Connector 72">
            <a:extLst>
              <a:ext uri="{FF2B5EF4-FFF2-40B4-BE49-F238E27FC236}">
                <a16:creationId xmlns:a16="http://schemas.microsoft.com/office/drawing/2014/main" id="{01EA4EC4-D3C1-0E45-ADB6-6CF4F66FBEA8}"/>
              </a:ext>
            </a:extLst>
          </p:cNvPr>
          <p:cNvCxnSpPr>
            <a:cxnSpLocks/>
            <a:stCxn id="71" idx="3"/>
            <a:endCxn id="32" idx="0"/>
          </p:cNvCxnSpPr>
          <p:nvPr/>
        </p:nvCxnSpPr>
        <p:spPr>
          <a:xfrm flipV="1">
            <a:off x="4062043" y="5454853"/>
            <a:ext cx="4288845" cy="127249"/>
          </a:xfrm>
          <a:prstGeom prst="bentConnector4">
            <a:avLst>
              <a:gd name="adj1" fmla="val 42628"/>
              <a:gd name="adj2" fmla="val 212514"/>
            </a:avLst>
          </a:prstGeom>
          <a:ln w="19050">
            <a:solidFill>
              <a:schemeClr val="accent2">
                <a:lumMod val="40000"/>
                <a:lumOff val="6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tangle 79">
            <a:extLst>
              <a:ext uri="{FF2B5EF4-FFF2-40B4-BE49-F238E27FC236}">
                <a16:creationId xmlns:a16="http://schemas.microsoft.com/office/drawing/2014/main" id="{79915AF7-B40D-E64E-9ED0-A96F8EEC1FC7}"/>
              </a:ext>
            </a:extLst>
          </p:cNvPr>
          <p:cNvSpPr/>
          <p:nvPr/>
        </p:nvSpPr>
        <p:spPr>
          <a:xfrm>
            <a:off x="3852372" y="5955004"/>
            <a:ext cx="392051" cy="638278"/>
          </a:xfrm>
          <a:prstGeom prst="rect">
            <a:avLst/>
          </a:prstGeom>
          <a:solidFill>
            <a:schemeClr val="accent2">
              <a:lumMod val="40000"/>
              <a:lumOff val="60000"/>
              <a:alpha val="3268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3E2596A-EDFC-F542-9476-68BAB018847E}"/>
              </a:ext>
            </a:extLst>
          </p:cNvPr>
          <p:cNvSpPr txBox="1"/>
          <p:nvPr/>
        </p:nvSpPr>
        <p:spPr>
          <a:xfrm>
            <a:off x="3852614" y="6359425"/>
            <a:ext cx="38503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T image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at 40-45</a:t>
            </a:r>
          </a:p>
        </p:txBody>
      </p:sp>
      <p:cxnSp>
        <p:nvCxnSpPr>
          <p:cNvPr id="82" name="Elbow Connector 81">
            <a:extLst>
              <a:ext uri="{FF2B5EF4-FFF2-40B4-BE49-F238E27FC236}">
                <a16:creationId xmlns:a16="http://schemas.microsoft.com/office/drawing/2014/main" id="{5AED4899-A49D-3C4B-BE47-E4B564E0C5AF}"/>
              </a:ext>
            </a:extLst>
          </p:cNvPr>
          <p:cNvCxnSpPr>
            <a:cxnSpLocks/>
            <a:stCxn id="80" idx="3"/>
            <a:endCxn id="44" idx="1"/>
          </p:cNvCxnSpPr>
          <p:nvPr/>
        </p:nvCxnSpPr>
        <p:spPr>
          <a:xfrm flipV="1">
            <a:off x="4244423" y="5964006"/>
            <a:ext cx="1750015" cy="310137"/>
          </a:xfrm>
          <a:prstGeom prst="bentConnector3">
            <a:avLst>
              <a:gd name="adj1" fmla="val 50000"/>
            </a:avLst>
          </a:prstGeom>
          <a:ln w="19050">
            <a:solidFill>
              <a:schemeClr val="accent2">
                <a:lumMod val="40000"/>
                <a:lumOff val="6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150097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text, person&#10;&#10;Description automatically generated">
            <a:extLst>
              <a:ext uri="{FF2B5EF4-FFF2-40B4-BE49-F238E27FC236}">
                <a16:creationId xmlns:a16="http://schemas.microsoft.com/office/drawing/2014/main" id="{E2CEC678-48B0-41EF-8E45-5B4AD7B077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9" r="7059" b="12728"/>
          <a:stretch/>
        </p:blipFill>
        <p:spPr>
          <a:xfrm>
            <a:off x="2763642" y="3257593"/>
            <a:ext cx="1508760" cy="111517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F5D6C21-B038-4234-9334-71500CF8668D}"/>
              </a:ext>
            </a:extLst>
          </p:cNvPr>
          <p:cNvSpPr txBox="1"/>
          <p:nvPr/>
        </p:nvSpPr>
        <p:spPr>
          <a:xfrm>
            <a:off x="2929091" y="2643682"/>
            <a:ext cx="117786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DPKD136869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ge 50-55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FT140 Trp653Ter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959 G/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7FE7D0-CA39-4FAE-957B-80B0720F2C80}"/>
              </a:ext>
            </a:extLst>
          </p:cNvPr>
          <p:cNvSpPr txBox="1"/>
          <p:nvPr/>
        </p:nvSpPr>
        <p:spPr>
          <a:xfrm>
            <a:off x="4855561" y="2659994"/>
            <a:ext cx="117786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DPKD283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ge 80-85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FT140 Trp459Ter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77 G/A</a:t>
            </a:r>
          </a:p>
        </p:txBody>
      </p:sp>
      <p:pic>
        <p:nvPicPr>
          <p:cNvPr id="9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id="{1CA5CBFF-52C4-4B2D-9B35-228E79A9583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55" r="10484" b="6595"/>
          <a:stretch/>
        </p:blipFill>
        <p:spPr>
          <a:xfrm>
            <a:off x="4690112" y="3267836"/>
            <a:ext cx="1508760" cy="109728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15D9143-DE9F-494B-9846-2106F6A12B4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2" r="8106" b="12728"/>
          <a:stretch/>
        </p:blipFill>
        <p:spPr>
          <a:xfrm>
            <a:off x="6616581" y="3249946"/>
            <a:ext cx="1508760" cy="111517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E7C1B35-602D-47D2-A1E7-1C9A01DC4F4F}"/>
              </a:ext>
            </a:extLst>
          </p:cNvPr>
          <p:cNvSpPr txBox="1"/>
          <p:nvPr/>
        </p:nvSpPr>
        <p:spPr>
          <a:xfrm>
            <a:off x="6782030" y="2642104"/>
            <a:ext cx="1177862" cy="7848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DPKD83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ge 55-60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FT140 Arg1404Gln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211G/A</a:t>
            </a:r>
          </a:p>
        </p:txBody>
      </p:sp>
      <p:pic>
        <p:nvPicPr>
          <p:cNvPr id="14" name="Picture 13" descr="A close-up of a person's chest&#10;&#10;Description automatically generated with low confidence">
            <a:extLst>
              <a:ext uri="{FF2B5EF4-FFF2-40B4-BE49-F238E27FC236}">
                <a16:creationId xmlns:a16="http://schemas.microsoft.com/office/drawing/2014/main" id="{17198D27-A85B-4DE5-8F2C-B7561AC3D11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1" t="-1" r="5735" b="11747"/>
          <a:stretch/>
        </p:blipFill>
        <p:spPr>
          <a:xfrm>
            <a:off x="8377601" y="3243877"/>
            <a:ext cx="1508760" cy="118076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81C246E-2968-4EBB-B0D4-65266A10C1DD}"/>
              </a:ext>
            </a:extLst>
          </p:cNvPr>
          <p:cNvSpPr txBox="1"/>
          <p:nvPr/>
        </p:nvSpPr>
        <p:spPr>
          <a:xfrm>
            <a:off x="8543050" y="2636035"/>
            <a:ext cx="117786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DPKD15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ge 55-60</a:t>
            </a:r>
          </a:p>
          <a:p>
            <a:pPr algn="ctr"/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FT140 Met444Val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330 A/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B446456-78C5-2043-BB83-7FCC417EE124}"/>
              </a:ext>
            </a:extLst>
          </p:cNvPr>
          <p:cNvSpPr txBox="1"/>
          <p:nvPr/>
        </p:nvSpPr>
        <p:spPr>
          <a:xfrm>
            <a:off x="2340468" y="1990526"/>
            <a:ext cx="784856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0744200" algn="l"/>
              </a:tabLst>
            </a:pP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 Imaging from participants with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IFT140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variants.</a:t>
            </a:r>
          </a:p>
        </p:txBody>
      </p:sp>
    </p:spTree>
    <p:extLst>
      <p:ext uri="{BB962C8B-B14F-4D97-AF65-F5344CB8AC3E}">
        <p14:creationId xmlns:p14="http://schemas.microsoft.com/office/powerpoint/2010/main" val="1129559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1</TotalTime>
  <Words>1047</Words>
  <Application>Microsoft Office PowerPoint</Application>
  <PresentationFormat>Widescreen</PresentationFormat>
  <Paragraphs>386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shahi, Tooraj</dc:creator>
  <cp:lastModifiedBy>Mirshahi, Tooraj</cp:lastModifiedBy>
  <cp:revision>7</cp:revision>
  <dcterms:created xsi:type="dcterms:W3CDTF">2022-01-30T19:13:52Z</dcterms:created>
  <dcterms:modified xsi:type="dcterms:W3CDTF">2022-03-14T15:11:48Z</dcterms:modified>
</cp:coreProperties>
</file>